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5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04"/>
    <p:restoredTop sz="94444"/>
  </p:normalViewPr>
  <p:slideViewPr>
    <p:cSldViewPr snapToGrid="0" snapToObjects="1">
      <p:cViewPr varScale="1">
        <p:scale>
          <a:sx n="68" d="100"/>
          <a:sy n="68" d="100"/>
        </p:scale>
        <p:origin x="316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0102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1044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379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091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834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860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5253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902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36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966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543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764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3A6E87C-577B-FA41-98F3-8DA0ACFB2A31}"/>
              </a:ext>
            </a:extLst>
          </p:cNvPr>
          <p:cNvSpPr txBox="1"/>
          <p:nvPr/>
        </p:nvSpPr>
        <p:spPr>
          <a:xfrm>
            <a:off x="434340" y="434340"/>
            <a:ext cx="5943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i="1" dirty="0"/>
              <a:t>Supplementary Figure 4: </a:t>
            </a:r>
            <a:r>
              <a:rPr lang="en-AU" sz="1200" i="1" dirty="0"/>
              <a:t>Top upregulated KEGG/GO pathways.</a:t>
            </a:r>
          </a:p>
          <a:p>
            <a:r>
              <a:rPr lang="en-AU" sz="1200" dirty="0"/>
              <a:t>(A) Top 20 upregulated KEGG pathways (B) Top 20 upregulated GO pathway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6E1407B-AEE8-124C-B230-E8C2FD4C3C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6142833"/>
              </p:ext>
            </p:extLst>
          </p:nvPr>
        </p:nvGraphicFramePr>
        <p:xfrm>
          <a:off x="644854" y="1171554"/>
          <a:ext cx="5568291" cy="143169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26081">
                  <a:extLst>
                    <a:ext uri="{9D8B030D-6E8A-4147-A177-3AD203B41FA5}">
                      <a16:colId xmlns:a16="http://schemas.microsoft.com/office/drawing/2014/main" val="1365391817"/>
                    </a:ext>
                  </a:extLst>
                </a:gridCol>
                <a:gridCol w="2445343">
                  <a:extLst>
                    <a:ext uri="{9D8B030D-6E8A-4147-A177-3AD203B41FA5}">
                      <a16:colId xmlns:a16="http://schemas.microsoft.com/office/drawing/2014/main" val="1248512539"/>
                    </a:ext>
                  </a:extLst>
                </a:gridCol>
                <a:gridCol w="329090">
                  <a:extLst>
                    <a:ext uri="{9D8B030D-6E8A-4147-A177-3AD203B41FA5}">
                      <a16:colId xmlns:a16="http://schemas.microsoft.com/office/drawing/2014/main" val="2933210559"/>
                    </a:ext>
                  </a:extLst>
                </a:gridCol>
                <a:gridCol w="427816">
                  <a:extLst>
                    <a:ext uri="{9D8B030D-6E8A-4147-A177-3AD203B41FA5}">
                      <a16:colId xmlns:a16="http://schemas.microsoft.com/office/drawing/2014/main" val="1012737593"/>
                    </a:ext>
                  </a:extLst>
                </a:gridCol>
                <a:gridCol w="518315">
                  <a:extLst>
                    <a:ext uri="{9D8B030D-6E8A-4147-A177-3AD203B41FA5}">
                      <a16:colId xmlns:a16="http://schemas.microsoft.com/office/drawing/2014/main" val="2127550208"/>
                    </a:ext>
                  </a:extLst>
                </a:gridCol>
                <a:gridCol w="551224">
                  <a:extLst>
                    <a:ext uri="{9D8B030D-6E8A-4147-A177-3AD203B41FA5}">
                      <a16:colId xmlns:a16="http://schemas.microsoft.com/office/drawing/2014/main" val="3111691575"/>
                    </a:ext>
                  </a:extLst>
                </a:gridCol>
                <a:gridCol w="570422">
                  <a:extLst>
                    <a:ext uri="{9D8B030D-6E8A-4147-A177-3AD203B41FA5}">
                      <a16:colId xmlns:a16="http://schemas.microsoft.com/office/drawing/2014/main" val="4144738173"/>
                    </a:ext>
                  </a:extLst>
                </a:gridCol>
              </a:tblGrid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ID   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athway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N  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Up   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Down 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P.Up</a:t>
                      </a:r>
                      <a:r>
                        <a:rPr lang="en-AU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   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P.Down</a:t>
                      </a:r>
                      <a:endParaRPr lang="en-AU" sz="8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277770256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512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ECM-receptor interaction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60E-1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88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1500568806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74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rotein digestion and absorption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.72E-0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79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286528721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724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lutamatergic synapse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17E-0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7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2506638955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76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Bile secretion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19E-0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77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3662072019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5414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Dilated cardiomyopathy (DCM)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31E-0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75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3447234906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5412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Arrhythmogenic right ventricular cardiomyopathy (ARVC)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3E-0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8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4094962899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path:hsa04020   </a:t>
                      </a:r>
                      <a:endParaRPr lang="en-AU" sz="8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Calcium </a:t>
                      </a:r>
                      <a:r>
                        <a:rPr lang="en-AU" sz="800" u="none" strike="noStrike" dirty="0" err="1">
                          <a:solidFill>
                            <a:sysClr val="windowText" lastClr="000000"/>
                          </a:solidFill>
                          <a:effectLst/>
                        </a:rPr>
                        <a:t>signaling</a:t>
                      </a:r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 pathway       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27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6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.11E-05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9.50E-01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1940667901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360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Axon guidance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41E-0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.2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734427990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2010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ABC transporters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70E-0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0E+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198704753"/>
                  </a:ext>
                </a:extLst>
              </a:tr>
              <a:tr h="121884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path:hsa05410   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Hypertrophic cardiomyopathy (HCM)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.12E-0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9.65E-0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633554732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770B175-C099-AA40-ABF8-D5E183AA3E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3837343"/>
              </p:ext>
            </p:extLst>
          </p:nvPr>
        </p:nvGraphicFramePr>
        <p:xfrm>
          <a:off x="650968" y="2598063"/>
          <a:ext cx="5562177" cy="13015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26081">
                  <a:extLst>
                    <a:ext uri="{9D8B030D-6E8A-4147-A177-3AD203B41FA5}">
                      <a16:colId xmlns:a16="http://schemas.microsoft.com/office/drawing/2014/main" val="3117785290"/>
                    </a:ext>
                  </a:extLst>
                </a:gridCol>
                <a:gridCol w="2442754">
                  <a:extLst>
                    <a:ext uri="{9D8B030D-6E8A-4147-A177-3AD203B41FA5}">
                      <a16:colId xmlns:a16="http://schemas.microsoft.com/office/drawing/2014/main" val="2750095738"/>
                    </a:ext>
                  </a:extLst>
                </a:gridCol>
                <a:gridCol w="326571">
                  <a:extLst>
                    <a:ext uri="{9D8B030D-6E8A-4147-A177-3AD203B41FA5}">
                      <a16:colId xmlns:a16="http://schemas.microsoft.com/office/drawing/2014/main" val="3284785177"/>
                    </a:ext>
                  </a:extLst>
                </a:gridCol>
                <a:gridCol w="431075">
                  <a:extLst>
                    <a:ext uri="{9D8B030D-6E8A-4147-A177-3AD203B41FA5}">
                      <a16:colId xmlns:a16="http://schemas.microsoft.com/office/drawing/2014/main" val="1094603397"/>
                    </a:ext>
                  </a:extLst>
                </a:gridCol>
                <a:gridCol w="509451">
                  <a:extLst>
                    <a:ext uri="{9D8B030D-6E8A-4147-A177-3AD203B41FA5}">
                      <a16:colId xmlns:a16="http://schemas.microsoft.com/office/drawing/2014/main" val="2986540067"/>
                    </a:ext>
                  </a:extLst>
                </a:gridCol>
                <a:gridCol w="561703">
                  <a:extLst>
                    <a:ext uri="{9D8B030D-6E8A-4147-A177-3AD203B41FA5}">
                      <a16:colId xmlns:a16="http://schemas.microsoft.com/office/drawing/2014/main" val="3146971146"/>
                    </a:ext>
                  </a:extLst>
                </a:gridCol>
                <a:gridCol w="564542">
                  <a:extLst>
                    <a:ext uri="{9D8B030D-6E8A-4147-A177-3AD203B41FA5}">
                      <a16:colId xmlns:a16="http://schemas.microsoft.com/office/drawing/2014/main" val="2988064925"/>
                    </a:ext>
                  </a:extLst>
                </a:gridCol>
              </a:tblGrid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015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p1 </a:t>
                      </a:r>
                      <a:r>
                        <a:rPr lang="en-AU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ignaling</a:t>
                      </a:r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pathway  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108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7.15E-05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8.84E-01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2170965291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151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I3K-Akt </a:t>
                      </a:r>
                      <a:r>
                        <a:rPr lang="en-AU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ignaling</a:t>
                      </a:r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pathway      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173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43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21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.34E-04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chemeClr val="tx1"/>
                          </a:solidFill>
                          <a:effectLst/>
                        </a:rPr>
                        <a:t>5.93E-01</a:t>
                      </a:r>
                      <a:endParaRPr lang="en-AU" sz="8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866719749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024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MP </a:t>
                      </a:r>
                      <a:r>
                        <a:rPr lang="en-AU" sz="8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ignaling</a:t>
                      </a:r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 pathway  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94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7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2.06E-04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chemeClr val="tx1"/>
                          </a:solidFill>
                          <a:effectLst/>
                        </a:rPr>
                        <a:t>3.91E-01</a:t>
                      </a:r>
                      <a:endParaRPr lang="en-AU" sz="8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3519767476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11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Insulin secretion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47E-0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6.75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55246885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5033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Nicotine addiction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.25E-0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0E+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4209784413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72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ncreatic secretion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7.83E-0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26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781667801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21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Oxytocin signaling pathway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5E-0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.76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91282163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510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Focal adhesion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12E-0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72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2912511404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3320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PAR </a:t>
                      </a:r>
                      <a:r>
                        <a:rPr lang="en-AU" sz="800" u="none" strike="noStrike" dirty="0" err="1">
                          <a:solidFill>
                            <a:sysClr val="windowText" lastClr="000000"/>
                          </a:solidFill>
                          <a:effectLst/>
                        </a:rPr>
                        <a:t>signaling</a:t>
                      </a:r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 pathway  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5</a:t>
                      </a:r>
                      <a:endParaRPr lang="en-AU" sz="800" b="0" i="0" u="none" strike="noStrike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0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0</a:t>
                      </a:r>
                      <a:endParaRPr lang="en-AU" sz="800" b="0" i="0" u="none" strike="noStrike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.49E-03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.00E+00</a:t>
                      </a:r>
                      <a:endParaRPr lang="en-AU" sz="8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97394594"/>
                  </a:ext>
                </a:extLst>
              </a:tr>
              <a:tr h="129935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ath:hsa04930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Type II diabetes mellitus       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3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2.01E-03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3.18E-0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34" marR="8234" marT="8234" marB="0" anchor="b"/>
                </a:tc>
                <a:extLst>
                  <a:ext uri="{0D108BD9-81ED-4DB2-BD59-A6C34878D82A}">
                    <a16:rowId xmlns:a16="http://schemas.microsoft.com/office/drawing/2014/main" val="4206709921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DD5FE3B-FEA7-9A47-92B0-8A881DFFBE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9658301"/>
              </p:ext>
            </p:extLst>
          </p:nvPr>
        </p:nvGraphicFramePr>
        <p:xfrm>
          <a:off x="623072" y="4279063"/>
          <a:ext cx="5569913" cy="30815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30482">
                  <a:extLst>
                    <a:ext uri="{9D8B030D-6E8A-4147-A177-3AD203B41FA5}">
                      <a16:colId xmlns:a16="http://schemas.microsoft.com/office/drawing/2014/main" val="2219244428"/>
                    </a:ext>
                  </a:extLst>
                </a:gridCol>
                <a:gridCol w="2441642">
                  <a:extLst>
                    <a:ext uri="{9D8B030D-6E8A-4147-A177-3AD203B41FA5}">
                      <a16:colId xmlns:a16="http://schemas.microsoft.com/office/drawing/2014/main" val="810262607"/>
                    </a:ext>
                  </a:extLst>
                </a:gridCol>
                <a:gridCol w="330741">
                  <a:extLst>
                    <a:ext uri="{9D8B030D-6E8A-4147-A177-3AD203B41FA5}">
                      <a16:colId xmlns:a16="http://schemas.microsoft.com/office/drawing/2014/main" val="3571816955"/>
                    </a:ext>
                  </a:extLst>
                </a:gridCol>
                <a:gridCol w="437744">
                  <a:extLst>
                    <a:ext uri="{9D8B030D-6E8A-4147-A177-3AD203B41FA5}">
                      <a16:colId xmlns:a16="http://schemas.microsoft.com/office/drawing/2014/main" val="2945462762"/>
                    </a:ext>
                  </a:extLst>
                </a:gridCol>
                <a:gridCol w="496111">
                  <a:extLst>
                    <a:ext uri="{9D8B030D-6E8A-4147-A177-3AD203B41FA5}">
                      <a16:colId xmlns:a16="http://schemas.microsoft.com/office/drawing/2014/main" val="3972352925"/>
                    </a:ext>
                  </a:extLst>
                </a:gridCol>
                <a:gridCol w="578490">
                  <a:extLst>
                    <a:ext uri="{9D8B030D-6E8A-4147-A177-3AD203B41FA5}">
                      <a16:colId xmlns:a16="http://schemas.microsoft.com/office/drawing/2014/main" val="993643664"/>
                    </a:ext>
                  </a:extLst>
                </a:gridCol>
                <a:gridCol w="554703">
                  <a:extLst>
                    <a:ext uri="{9D8B030D-6E8A-4147-A177-3AD203B41FA5}">
                      <a16:colId xmlns:a16="http://schemas.microsoft.com/office/drawing/2014/main" val="1439693972"/>
                    </a:ext>
                  </a:extLst>
                </a:gridCol>
              </a:tblGrid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effectLst/>
                        </a:rPr>
                        <a:t>ID      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effectLst/>
                        </a:rPr>
                        <a:t>Pathway 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>
                          <a:effectLst/>
                        </a:rPr>
                        <a:t>N       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>
                          <a:effectLst/>
                        </a:rPr>
                        <a:t>Up      </a:t>
                      </a:r>
                      <a:endParaRPr lang="en-AU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>
                          <a:effectLst/>
                        </a:rPr>
                        <a:t>Down    </a:t>
                      </a:r>
                      <a:endParaRPr lang="en-AU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 err="1">
                          <a:effectLst/>
                        </a:rPr>
                        <a:t>P.Up</a:t>
                      </a:r>
                      <a:r>
                        <a:rPr lang="en-AU" sz="800" b="1" u="none" strike="noStrike" dirty="0">
                          <a:effectLst/>
                        </a:rPr>
                        <a:t>    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b="1" u="none" strike="noStrike" dirty="0" err="1">
                          <a:effectLst/>
                        </a:rPr>
                        <a:t>P.Down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597300890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71944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cell periphery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02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46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194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2.56E-28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64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55786894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GO:0005886      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lasma membrane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97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5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8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66E-2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69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3893989576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2995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cell projection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2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4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7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68E-2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9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602461596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4459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lasma membrane part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9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4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9E-1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2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977104093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5578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roteinaceous extracellular matrix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21E-1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8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4119859421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31224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intrinsic component of membrane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00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.68E-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0E+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615561071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32501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 dirty="0">
                          <a:effectLst/>
                        </a:rPr>
                        <a:t>multicellular organismal process         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99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8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2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08E-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87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59547365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16021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integral component of membrane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98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1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09E-1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0E+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363995037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6928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movement of cell or subcellular component 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87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2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33E-1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6.82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28424582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3008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system process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5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5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52E-1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7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09666237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98590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plasma membrane region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8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1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91E-1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9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3902680289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8731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system development  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02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2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03E-1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9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129443895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8856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anatomical structure development  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59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0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8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7.82E-1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51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346449439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7399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nervous system development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01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4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.66E-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7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185417333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9653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anatomical structure morphogenesis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238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7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0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.55E-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3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80392335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4463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cell projection part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8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3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69E-1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9.99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965198565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07275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multicellular organism development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29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56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59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18E-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52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85067507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8858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cell projection morphogenesis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40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2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7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29E-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00E+00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564015219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4707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single-multicellular organism process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279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53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13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.25E-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.40E-01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130438724"/>
                  </a:ext>
                </a:extLst>
              </a:tr>
              <a:tr h="146741"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GO:0040011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Arial Unicode MS" panose="020B0604020202020204" pitchFamily="34" charset="-128"/>
                        <a:ea typeface="Arial Unicode MS" panose="020B0604020202020204" pitchFamily="34" charset="-128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800" u="none" strike="noStrike">
                          <a:effectLst/>
                        </a:rPr>
                        <a:t>locomotion      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724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182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75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>
                          <a:effectLst/>
                        </a:rPr>
                        <a:t>3.71E-14</a:t>
                      </a:r>
                      <a:endParaRPr lang="en-AU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800" u="none" strike="noStrike" dirty="0">
                          <a:effectLst/>
                        </a:rPr>
                        <a:t>6.66E-01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2" marR="7662" marT="7662" marB="0" anchor="b"/>
                </a:tc>
                <a:extLst>
                  <a:ext uri="{0D108BD9-81ED-4DB2-BD59-A6C34878D82A}">
                    <a16:rowId xmlns:a16="http://schemas.microsoft.com/office/drawing/2014/main" val="2111228941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15E9092-3E3D-BC43-B76D-D8785E31EC3A}"/>
              </a:ext>
            </a:extLst>
          </p:cNvPr>
          <p:cNvSpPr txBox="1"/>
          <p:nvPr/>
        </p:nvSpPr>
        <p:spPr>
          <a:xfrm>
            <a:off x="58100" y="117155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629BA3-9002-F545-94C3-F18732FFEE94}"/>
              </a:ext>
            </a:extLst>
          </p:cNvPr>
          <p:cNvSpPr txBox="1"/>
          <p:nvPr/>
        </p:nvSpPr>
        <p:spPr>
          <a:xfrm>
            <a:off x="58100" y="4214625"/>
            <a:ext cx="585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415795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2</TotalTime>
  <Words>506</Words>
  <Application>Microsoft Macintosh PowerPoint</Application>
  <PresentationFormat>Custom</PresentationFormat>
  <Paragraphs>2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 Unicode M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ooke</dc:creator>
  <cp:lastModifiedBy>Rachel Cooke</cp:lastModifiedBy>
  <cp:revision>27</cp:revision>
  <dcterms:created xsi:type="dcterms:W3CDTF">2019-05-25T03:52:18Z</dcterms:created>
  <dcterms:modified xsi:type="dcterms:W3CDTF">2020-07-12T04:26:00Z</dcterms:modified>
</cp:coreProperties>
</file>